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-99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K Stability'!$G$9</c:f>
              <c:strCache>
                <c:ptCount val="1"/>
                <c:pt idx="0">
                  <c:v>H128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PK Stability'!$I$10:$I$14</c:f>
                <c:numCache>
                  <c:formatCode>General</c:formatCode>
                  <c:ptCount val="5"/>
                  <c:pt idx="0">
                    <c:v>159.98426182487518</c:v>
                  </c:pt>
                  <c:pt idx="1">
                    <c:v>145.84113662719258</c:v>
                  </c:pt>
                  <c:pt idx="2">
                    <c:v>812.26475845517803</c:v>
                  </c:pt>
                  <c:pt idx="3">
                    <c:v>310.22362561142069</c:v>
                  </c:pt>
                  <c:pt idx="4">
                    <c:v>857.68604477825727</c:v>
                  </c:pt>
                </c:numCache>
              </c:numRef>
            </c:plus>
            <c:minus>
              <c:numRef>
                <c:f>'PK Stability'!$I$10:$I$14</c:f>
                <c:numCache>
                  <c:formatCode>General</c:formatCode>
                  <c:ptCount val="5"/>
                  <c:pt idx="0">
                    <c:v>159.98426182487518</c:v>
                  </c:pt>
                  <c:pt idx="1">
                    <c:v>145.84113662719258</c:v>
                  </c:pt>
                  <c:pt idx="2">
                    <c:v>812.26475845517803</c:v>
                  </c:pt>
                  <c:pt idx="3">
                    <c:v>310.22362561142069</c:v>
                  </c:pt>
                  <c:pt idx="4">
                    <c:v>857.68604477825727</c:v>
                  </c:pt>
                </c:numCache>
              </c:numRef>
            </c:minus>
          </c:errBars>
          <c:cat>
            <c:numRef>
              <c:f>'PK Stability'!$F$10:$F$14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24</c:v>
                </c:pt>
                <c:pt idx="3">
                  <c:v>48</c:v>
                </c:pt>
                <c:pt idx="4">
                  <c:v>72</c:v>
                </c:pt>
              </c:numCache>
            </c:numRef>
          </c:cat>
          <c:val>
            <c:numRef>
              <c:f>'PK Stability'!$G$10:$G$14</c:f>
              <c:numCache>
                <c:formatCode>0</c:formatCode>
                <c:ptCount val="5"/>
                <c:pt idx="0">
                  <c:v>11191.209103712727</c:v>
                </c:pt>
                <c:pt idx="1">
                  <c:v>12271.871575003488</c:v>
                </c:pt>
                <c:pt idx="2">
                  <c:v>11868.450240470573</c:v>
                </c:pt>
                <c:pt idx="3">
                  <c:v>11847.562409314953</c:v>
                </c:pt>
                <c:pt idx="4">
                  <c:v>12303.65290930676</c:v>
                </c:pt>
              </c:numCache>
            </c:numRef>
          </c:val>
        </c:ser>
        <c:ser>
          <c:idx val="1"/>
          <c:order val="1"/>
          <c:tx>
            <c:strRef>
              <c:f>'PK Stability'!$H$9</c:f>
              <c:strCache>
                <c:ptCount val="1"/>
                <c:pt idx="0">
                  <c:v>H146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PK Stability'!$J$10:$J$14</c:f>
                <c:numCache>
                  <c:formatCode>General</c:formatCode>
                  <c:ptCount val="5"/>
                  <c:pt idx="0">
                    <c:v>207.36613066894282</c:v>
                  </c:pt>
                  <c:pt idx="1">
                    <c:v>427.07576615406339</c:v>
                  </c:pt>
                  <c:pt idx="2">
                    <c:v>892.75450045189643</c:v>
                  </c:pt>
                  <c:pt idx="3">
                    <c:v>738.10078542617077</c:v>
                  </c:pt>
                  <c:pt idx="4">
                    <c:v>1318.37106491502</c:v>
                  </c:pt>
                </c:numCache>
              </c:numRef>
            </c:plus>
            <c:minus>
              <c:numRef>
                <c:f>'PK Stability'!$J$10:$J$14</c:f>
                <c:numCache>
                  <c:formatCode>General</c:formatCode>
                  <c:ptCount val="5"/>
                  <c:pt idx="0">
                    <c:v>207.36613066894282</c:v>
                  </c:pt>
                  <c:pt idx="1">
                    <c:v>427.07576615406339</c:v>
                  </c:pt>
                  <c:pt idx="2">
                    <c:v>892.75450045189643</c:v>
                  </c:pt>
                  <c:pt idx="3">
                    <c:v>738.10078542617077</c:v>
                  </c:pt>
                  <c:pt idx="4">
                    <c:v>1318.37106491502</c:v>
                  </c:pt>
                </c:numCache>
              </c:numRef>
            </c:minus>
          </c:errBars>
          <c:cat>
            <c:numRef>
              <c:f>'PK Stability'!$F$10:$F$14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24</c:v>
                </c:pt>
                <c:pt idx="3">
                  <c:v>48</c:v>
                </c:pt>
                <c:pt idx="4">
                  <c:v>72</c:v>
                </c:pt>
              </c:numCache>
            </c:numRef>
          </c:cat>
          <c:val>
            <c:numRef>
              <c:f>'PK Stability'!$H$10:$H$14</c:f>
              <c:numCache>
                <c:formatCode>0</c:formatCode>
                <c:ptCount val="5"/>
                <c:pt idx="0">
                  <c:v>12039.105133954959</c:v>
                </c:pt>
                <c:pt idx="1">
                  <c:v>12312.972978964548</c:v>
                </c:pt>
                <c:pt idx="2">
                  <c:v>11686.327274643927</c:v>
                </c:pt>
                <c:pt idx="3">
                  <c:v>11717.018557617814</c:v>
                </c:pt>
                <c:pt idx="4">
                  <c:v>12485.36958731843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9868160"/>
        <c:axId val="221237248"/>
      </c:barChart>
      <c:catAx>
        <c:axId val="8986816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</a:t>
                </a:r>
                <a:r>
                  <a:rPr lang="en-US" baseline="0"/>
                  <a:t> (Hours)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200" b="1"/>
            </a:pPr>
            <a:endParaRPr lang="en-US"/>
          </a:p>
        </c:txPr>
        <c:crossAx val="221237248"/>
        <c:crosses val="autoZero"/>
        <c:auto val="1"/>
        <c:lblAlgn val="ctr"/>
        <c:lblOffset val="100"/>
        <c:noMultiLvlLbl val="0"/>
      </c:catAx>
      <c:valAx>
        <c:axId val="221237248"/>
        <c:scaling>
          <c:orientation val="minMax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 baseline="0" dirty="0" smtClean="0"/>
                  <a:t>ABT-888 (ng/ml)</a:t>
                </a:r>
                <a:endParaRPr lang="en-US" sz="1600" dirty="0"/>
              </a:p>
            </c:rich>
          </c:tx>
          <c:layout/>
          <c:overlay val="0"/>
        </c:title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sz="1200" b="1"/>
            </a:pPr>
            <a:endParaRPr lang="en-US"/>
          </a:p>
        </c:txPr>
        <c:crossAx val="89868160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1400"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4F9217-B40D-47D5-BE1F-22E5D5FA944C}" type="datetimeFigureOut">
              <a:rPr lang="en-US" smtClean="0"/>
              <a:t>2/11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06D640-E1C2-41A5-BD33-E735AD5F9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6352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Unsupervised cluster analysis of Illumina</a:t>
            </a:r>
            <a:r>
              <a:rPr lang="en-US" baseline="0" dirty="0" smtClean="0"/>
              <a:t> gene expression data for a comprehensive list of DNA repair genes showed no discernible interaction of DNA-repair gene expression and specific treatment conditions. Cells were observed to cluster together mainly based on cell of origin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105C7F-1137-4179-92CD-57F98C66D226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defTabSz="914334">
              <a:defRPr/>
            </a:pPr>
            <a:r>
              <a:rPr lang="en-US" dirty="0" smtClean="0"/>
              <a:t>Based</a:t>
            </a:r>
            <a:r>
              <a:rPr lang="en-US" baseline="0" dirty="0" smtClean="0"/>
              <a:t> on the observed differential </a:t>
            </a:r>
            <a:r>
              <a:rPr lang="en-US" baseline="0" dirty="0" err="1" smtClean="0"/>
              <a:t>modualtion</a:t>
            </a:r>
            <a:r>
              <a:rPr lang="en-US" baseline="0" dirty="0" smtClean="0"/>
              <a:t> of DNA-PKcs in the time course experiments between sensitive and insensitive cells, we performed a supervised analysis that included </a:t>
            </a:r>
            <a:r>
              <a:rPr lang="en-US" dirty="0" smtClean="0"/>
              <a:t>DNA-PKcs</a:t>
            </a:r>
            <a:r>
              <a:rPr lang="en-US" baseline="0" dirty="0" smtClean="0"/>
              <a:t> (PRKDC) expression data along with the 23-gene panel of interest. The forced inclusion of PRKDC expression data altered the clustering pattern obtained from the previous unsupervised analysis of the </a:t>
            </a:r>
            <a:r>
              <a:rPr lang="en-US" baseline="0" dirty="0" err="1" smtClean="0"/>
              <a:t>illumina</a:t>
            </a:r>
            <a:r>
              <a:rPr lang="en-US" baseline="0" dirty="0" smtClean="0"/>
              <a:t> (left) and </a:t>
            </a:r>
            <a:r>
              <a:rPr lang="en-US" baseline="0" dirty="0" err="1" smtClean="0"/>
              <a:t>nanoString</a:t>
            </a:r>
            <a:r>
              <a:rPr lang="en-US" baseline="0" dirty="0" smtClean="0"/>
              <a:t> data; noticeably, H187 cell line clustered along with the PARP inhibitor insensitive group in the </a:t>
            </a:r>
            <a:r>
              <a:rPr lang="en-US" baseline="0" dirty="0" err="1" smtClean="0"/>
              <a:t>nanoString</a:t>
            </a:r>
            <a:r>
              <a:rPr lang="en-US" baseline="0" dirty="0" smtClean="0"/>
              <a:t> data. Consistent with the Western blot data, normalized PRKDC expression intensity on both the Illumina and the nanoString platforms was low in the 5 SCLC cell lines (DMS153, H146, H526, H209 and H187) that displayed greater sensitivity to cisplatin and ABT-888 potentiation and higher in the less sensitive cell group (D114, DMS53, H69, H128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105C7F-1137-4179-92CD-57F98C66D226}" type="slidenum">
              <a:rPr lang="en-US" smtClean="0">
                <a:solidFill>
                  <a:prstClr val="black"/>
                </a:solidFill>
              </a:rPr>
              <a:pPr/>
              <a:t>2</a:t>
            </a:fld>
            <a:endParaRPr lang="en-US">
              <a:solidFill>
                <a:prstClr val="black"/>
              </a:solidFill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105C7F-1137-4179-92CD-57F98C66D226}" type="slidenum">
              <a:rPr lang="en-US" smtClean="0">
                <a:solidFill>
                  <a:prstClr val="black"/>
                </a:solidFill>
              </a:rPr>
              <a:pPr/>
              <a:t>3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546892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C9FD6-B2ED-4648-BA90-A90C343FC4F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2/11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B5A01-0340-45F6-8000-DD2176D52C3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814630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C9FD6-B2ED-4648-BA90-A90C343FC4F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2/11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B5A01-0340-45F6-8000-DD2176D52C3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50182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C9FD6-B2ED-4648-BA90-A90C343FC4F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2/11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B5A01-0340-45F6-8000-DD2176D52C3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683789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C9FD6-B2ED-4648-BA90-A90C343FC4F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2/11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B5A01-0340-45F6-8000-DD2176D52C3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86966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C9FD6-B2ED-4648-BA90-A90C343FC4F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2/11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B5A01-0340-45F6-8000-DD2176D52C3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676250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C9FD6-B2ED-4648-BA90-A90C343FC4F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2/11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B5A01-0340-45F6-8000-DD2176D52C3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097045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C9FD6-B2ED-4648-BA90-A90C343FC4F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2/11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B5A01-0340-45F6-8000-DD2176D52C3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63476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C9FD6-B2ED-4648-BA90-A90C343FC4F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2/11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B5A01-0340-45F6-8000-DD2176D52C3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35487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C9FD6-B2ED-4648-BA90-A90C343FC4F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2/11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B5A01-0340-45F6-8000-DD2176D52C3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85749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C9FD6-B2ED-4648-BA90-A90C343FC4F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2/11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B5A01-0340-45F6-8000-DD2176D52C3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26247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C9FD6-B2ED-4648-BA90-A90C343FC4F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2/11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AB5A01-0340-45F6-8000-DD2176D52C3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512397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7C9FD6-B2ED-4648-BA90-A90C343FC4F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2/11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AB5A01-0340-45F6-8000-DD2176D52C3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24701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307529"/>
            <a:ext cx="8229600" cy="1077218"/>
          </a:xfrm>
        </p:spPr>
        <p:txBody>
          <a:bodyPr>
            <a:normAutofit/>
          </a:bodyPr>
          <a:lstStyle/>
          <a:p>
            <a:r>
              <a:rPr lang="en-US" sz="3200" dirty="0" smtClean="0">
                <a:latin typeface="Helvetica" pitchFamily="34" charset="0"/>
                <a:cs typeface="Helvetica" pitchFamily="34" charset="0"/>
              </a:rPr>
              <a:t>S1: Unsupervised analysis of DNA-repair gene expression from the Illumina platform </a:t>
            </a:r>
            <a:endParaRPr lang="en-US" sz="3200" dirty="0">
              <a:latin typeface="Helvetica" pitchFamily="34" charset="0"/>
              <a:cs typeface="Helvetica" pitchFamily="34" charset="0"/>
            </a:endParaRPr>
          </a:p>
        </p:txBody>
      </p:sp>
      <p:pic>
        <p:nvPicPr>
          <p:cNvPr id="4" name="Content Placeholder 3" descr="D:\TaofeekOwonikoko\Data\TOW1_analysis\images\HC_DNArepair.jpeg"/>
          <p:cNvPicPr>
            <a:picLocks noGrp="1" noChangeAspect="1" noChangeArrowheads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" y="1420394"/>
            <a:ext cx="8134517" cy="52090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7774610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3600" dirty="0" smtClean="0">
                <a:latin typeface="Helvetica" pitchFamily="34" charset="0"/>
                <a:cs typeface="Helvetica" pitchFamily="34" charset="0"/>
              </a:rPr>
              <a:t>S2: Illumina and nCounter NanoString </a:t>
            </a:r>
            <a:r>
              <a:rPr lang="en-US" sz="3600" dirty="0">
                <a:latin typeface="Helvetica" pitchFamily="34" charset="0"/>
                <a:cs typeface="Helvetica" pitchFamily="34" charset="0"/>
              </a:rPr>
              <a:t>expression </a:t>
            </a:r>
            <a:r>
              <a:rPr lang="en-US" sz="3600" dirty="0" smtClean="0">
                <a:latin typeface="Helvetica" pitchFamily="34" charset="0"/>
                <a:cs typeface="Helvetica" pitchFamily="34" charset="0"/>
              </a:rPr>
              <a:t>data including PRKDC</a:t>
            </a:r>
            <a:endParaRPr lang="en-US" sz="3600" dirty="0">
              <a:latin typeface="Helvetica" pitchFamily="34" charset="0"/>
              <a:cs typeface="Helvetica" pitchFamily="34" charset="0"/>
            </a:endParaRPr>
          </a:p>
        </p:txBody>
      </p:sp>
      <p:pic>
        <p:nvPicPr>
          <p:cNvPr id="7" name="Picture 2"/>
          <p:cNvPicPr>
            <a:picLocks noGrp="1" noChangeAspect="1" noChangeArrowheads="1"/>
          </p:cNvPicPr>
          <p:nvPr>
            <p:ph sz="half" idx="2"/>
          </p:nvPr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648200" y="1858855"/>
            <a:ext cx="4038600" cy="42371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2"/>
          <p:cNvPicPr>
            <a:picLocks noGrp="1" noChangeAspect="1" noChangeArrowheads="1"/>
          </p:cNvPicPr>
          <p:nvPr>
            <p:ph sz="half" idx="1"/>
          </p:nvPr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57200" y="1792900"/>
            <a:ext cx="4038600" cy="4140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460026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3600" dirty="0" smtClean="0">
                <a:latin typeface="Helvetica" pitchFamily="34" charset="0"/>
                <a:cs typeface="Helvetica" pitchFamily="34" charset="0"/>
              </a:rPr>
              <a:t>S3: Stability of </a:t>
            </a:r>
            <a:r>
              <a:rPr lang="en-US" sz="3600" dirty="0" smtClean="0">
                <a:latin typeface="Helvetica" pitchFamily="34" charset="0"/>
                <a:cs typeface="Helvetica" pitchFamily="34" charset="0"/>
              </a:rPr>
              <a:t>ABT-888 </a:t>
            </a:r>
            <a:r>
              <a:rPr lang="en-US" sz="3600" dirty="0" smtClean="0">
                <a:latin typeface="Helvetica" pitchFamily="34" charset="0"/>
                <a:cs typeface="Helvetica" pitchFamily="34" charset="0"/>
              </a:rPr>
              <a:t>in </a:t>
            </a:r>
            <a:r>
              <a:rPr lang="en-US" sz="3600" dirty="0" smtClean="0">
                <a:latin typeface="Helvetica" pitchFamily="34" charset="0"/>
                <a:cs typeface="Helvetica" pitchFamily="34" charset="0"/>
              </a:rPr>
              <a:t>cell-containing </a:t>
            </a:r>
            <a:r>
              <a:rPr lang="en-US" sz="3600" dirty="0" smtClean="0">
                <a:latin typeface="Helvetica" pitchFamily="34" charset="0"/>
                <a:cs typeface="Helvetica" pitchFamily="34" charset="0"/>
              </a:rPr>
              <a:t>media over a 72 hour period</a:t>
            </a:r>
            <a:endParaRPr lang="en-US" sz="3600" dirty="0">
              <a:latin typeface="Helvetica" pitchFamily="34" charset="0"/>
              <a:cs typeface="Helvetica" pitchFamily="34" charset="0"/>
            </a:endParaRPr>
          </a:p>
        </p:txBody>
      </p:sp>
      <p:graphicFrame>
        <p:nvGraphicFramePr>
          <p:cNvPr id="7" name="Content Placeholder 6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193024468"/>
              </p:ext>
            </p:extLst>
          </p:nvPr>
        </p:nvGraphicFramePr>
        <p:xfrm>
          <a:off x="457200" y="1600200"/>
          <a:ext cx="8229600" cy="45259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847079154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7</Words>
  <Application>Microsoft Office PowerPoint</Application>
  <PresentationFormat>On-screen Show (4:3)</PresentationFormat>
  <Paragraphs>10</Paragraphs>
  <Slides>3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1_Office Theme</vt:lpstr>
      <vt:lpstr>S1: Unsupervised analysis of DNA-repair gene expression from the Illumina platform </vt:lpstr>
      <vt:lpstr>S2: Illumina and nCounter NanoString expression data including PRKDC</vt:lpstr>
      <vt:lpstr>S3: Stability of ABT-888 in cell-containing media over a 72 hour period</vt:lpstr>
    </vt:vector>
  </TitlesOfParts>
  <Company>Emory Healthcar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473406</dc:creator>
  <cp:lastModifiedBy>n473406</cp:lastModifiedBy>
  <cp:revision>2</cp:revision>
  <dcterms:created xsi:type="dcterms:W3CDTF">2014-02-12T00:09:40Z</dcterms:created>
  <dcterms:modified xsi:type="dcterms:W3CDTF">2014-02-12T00:10:33Z</dcterms:modified>
</cp:coreProperties>
</file>